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F7CF7F-CF43-45B3-9EA6-C6A92EC10F7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F64394-90BB-491C-8DB2-A69E2A71DF0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1332B7-8882-4807-9336-3A9B60B86A0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700828-8B75-41A0-9AA9-9D30B5AB6E8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A49BC2-BDE5-41D0-A7BE-427D72EAF78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7F51A7-54DF-4BEB-A64C-7DE60F1E26A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BB825C-9720-49E5-B8C7-707C487DA72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CE3577-DFB3-45CF-B348-1E5C4194249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D17B10-927C-4747-B9B8-64C06FD0208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F31F6A-7825-4695-A0E6-6888B55454C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B5D042-BB42-4C18-99DB-3F899D4B0D2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43E41F-C665-41C4-A035-AC9B517A82A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778FBAD-912F-41D1-BFB1-6A5B2906E4F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28"/>
          <p:cNvSpPr/>
          <p:nvPr/>
        </p:nvSpPr>
        <p:spPr>
          <a:xfrm>
            <a:off x="2576880" y="1386000"/>
            <a:ext cx="2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30"/>
          <p:cNvSpPr/>
          <p:nvPr/>
        </p:nvSpPr>
        <p:spPr>
          <a:xfrm>
            <a:off x="533520" y="2057400"/>
            <a:ext cx="18396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40"/>
          <p:cNvSpPr/>
          <p:nvPr/>
        </p:nvSpPr>
        <p:spPr>
          <a:xfrm>
            <a:off x="2058480" y="1295280"/>
            <a:ext cx="349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41"/>
          <p:cNvSpPr/>
          <p:nvPr/>
        </p:nvSpPr>
        <p:spPr>
          <a:xfrm>
            <a:off x="5852520" y="1219320"/>
            <a:ext cx="349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B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44"/>
          <p:cNvSpPr/>
          <p:nvPr/>
        </p:nvSpPr>
        <p:spPr>
          <a:xfrm>
            <a:off x="5929200" y="3900600"/>
            <a:ext cx="358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D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46"/>
          <p:cNvSpPr/>
          <p:nvPr/>
        </p:nvSpPr>
        <p:spPr>
          <a:xfrm>
            <a:off x="365040" y="395280"/>
            <a:ext cx="1093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igure S1.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42"/>
          <p:cNvSpPr/>
          <p:nvPr/>
        </p:nvSpPr>
        <p:spPr>
          <a:xfrm>
            <a:off x="2118960" y="3781440"/>
            <a:ext cx="3942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.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49"/>
          <p:cNvSpPr/>
          <p:nvPr/>
        </p:nvSpPr>
        <p:spPr>
          <a:xfrm>
            <a:off x="4572000" y="1523880"/>
            <a:ext cx="18432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68"/>
          <p:cNvSpPr/>
          <p:nvPr/>
        </p:nvSpPr>
        <p:spPr>
          <a:xfrm>
            <a:off x="2039760" y="1190520"/>
            <a:ext cx="18432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0" name="Group 72"/>
          <p:cNvGrpSpPr/>
          <p:nvPr/>
        </p:nvGrpSpPr>
        <p:grpSpPr>
          <a:xfrm>
            <a:off x="1989360" y="304920"/>
            <a:ext cx="5630760" cy="2211480"/>
            <a:chOff x="1989360" y="304920"/>
            <a:chExt cx="5630760" cy="2211480"/>
          </a:xfrm>
        </p:grpSpPr>
        <p:grpSp>
          <p:nvGrpSpPr>
            <p:cNvPr id="51" name="Group 64"/>
            <p:cNvGrpSpPr/>
            <p:nvPr/>
          </p:nvGrpSpPr>
          <p:grpSpPr>
            <a:xfrm>
              <a:off x="2748960" y="304920"/>
              <a:ext cx="2432880" cy="2135160"/>
              <a:chOff x="2748960" y="304920"/>
              <a:chExt cx="2432880" cy="2135160"/>
            </a:xfrm>
          </p:grpSpPr>
          <p:grpSp>
            <p:nvGrpSpPr>
              <p:cNvPr id="52" name="Group 24"/>
              <p:cNvGrpSpPr/>
              <p:nvPr/>
            </p:nvGrpSpPr>
            <p:grpSpPr>
              <a:xfrm>
                <a:off x="2901960" y="304920"/>
                <a:ext cx="2279880" cy="2135160"/>
                <a:chOff x="2901960" y="304920"/>
                <a:chExt cx="2279880" cy="2135160"/>
              </a:xfrm>
            </p:grpSpPr>
            <p:grpSp>
              <p:nvGrpSpPr>
                <p:cNvPr id="53" name="Group 22"/>
                <p:cNvGrpSpPr/>
                <p:nvPr/>
              </p:nvGrpSpPr>
              <p:grpSpPr>
                <a:xfrm>
                  <a:off x="2901960" y="304920"/>
                  <a:ext cx="2279880" cy="1978200"/>
                  <a:chOff x="2901960" y="304920"/>
                  <a:chExt cx="2279880" cy="1978200"/>
                </a:xfrm>
              </p:grpSpPr>
              <p:pic>
                <p:nvPicPr>
                  <p:cNvPr id="54" name="Picture 8" descr=""/>
                  <p:cNvPicPr/>
                  <p:nvPr/>
                </p:nvPicPr>
                <p:blipFill>
                  <a:blip r:embed="rId1"/>
                  <a:stretch/>
                </p:blipFill>
                <p:spPr>
                  <a:xfrm>
                    <a:off x="2978280" y="479520"/>
                    <a:ext cx="2203560" cy="1803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55" name="Rectangle 10"/>
                  <p:cNvSpPr/>
                  <p:nvPr/>
                </p:nvSpPr>
                <p:spPr>
                  <a:xfrm>
                    <a:off x="3587760" y="304920"/>
                    <a:ext cx="1219320" cy="304920"/>
                  </a:xfrm>
                  <a:prstGeom prst="rect">
                    <a:avLst/>
                  </a:pr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2400" spc="-1" strike="noStrike">
                        <a:solidFill>
                          <a:srgbClr val="000000"/>
                        </a:solidFill>
                        <a:latin typeface="ヒラギノ角ゴ ProN W3"/>
                      </a:rPr>
                      <a:t>_x0003_</a:t>
                    </a: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6" name="Rectangle 18"/>
                  <p:cNvSpPr/>
                  <p:nvPr/>
                </p:nvSpPr>
                <p:spPr>
                  <a:xfrm>
                    <a:off x="2901960" y="925560"/>
                    <a:ext cx="228600" cy="762120"/>
                  </a:xfrm>
                  <a:prstGeom prst="rect">
                    <a:avLst/>
                  </a:pr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57" name="Rectangle 14"/>
                <p:cNvSpPr/>
                <p:nvPr/>
              </p:nvSpPr>
              <p:spPr>
                <a:xfrm>
                  <a:off x="3587760" y="2135520"/>
                  <a:ext cx="1219320" cy="30456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400" spc="-1" strike="noStrike">
                      <a:solidFill>
                        <a:srgbClr val="000000"/>
                      </a:solidFill>
                      <a:latin typeface="ヒラギノ角ゴ ProN W3"/>
                    </a:rPr>
                    <a:t>_x0003_</a:t>
                  </a: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58" name="Rectangle 57"/>
              <p:cNvSpPr/>
              <p:nvPr/>
            </p:nvSpPr>
            <p:spPr>
              <a:xfrm>
                <a:off x="3511800" y="2133720"/>
                <a:ext cx="13449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GFP expressio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Text Box 60"/>
              <p:cNvSpPr/>
              <p:nvPr/>
            </p:nvSpPr>
            <p:spPr>
              <a:xfrm flipH="1" rot="16200000">
                <a:off x="2326680" y="1185840"/>
                <a:ext cx="1121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HA detectio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0" name="Group 65"/>
            <p:cNvGrpSpPr/>
            <p:nvPr/>
          </p:nvGrpSpPr>
          <p:grpSpPr>
            <a:xfrm>
              <a:off x="5263560" y="411120"/>
              <a:ext cx="2356560" cy="2105280"/>
              <a:chOff x="5263560" y="411120"/>
              <a:chExt cx="2356560" cy="2105280"/>
            </a:xfrm>
          </p:grpSpPr>
          <p:grpSp>
            <p:nvGrpSpPr>
              <p:cNvPr id="61" name="Group 25"/>
              <p:cNvGrpSpPr/>
              <p:nvPr/>
            </p:nvGrpSpPr>
            <p:grpSpPr>
              <a:xfrm>
                <a:off x="5340600" y="411120"/>
                <a:ext cx="2279520" cy="2090880"/>
                <a:chOff x="5340600" y="411120"/>
                <a:chExt cx="2279520" cy="2090880"/>
              </a:xfrm>
            </p:grpSpPr>
            <p:grpSp>
              <p:nvGrpSpPr>
                <p:cNvPr id="62" name="Group 23"/>
                <p:cNvGrpSpPr/>
                <p:nvPr/>
              </p:nvGrpSpPr>
              <p:grpSpPr>
                <a:xfrm>
                  <a:off x="5340600" y="411120"/>
                  <a:ext cx="2279520" cy="1955880"/>
                  <a:chOff x="5340600" y="411120"/>
                  <a:chExt cx="2279520" cy="1955880"/>
                </a:xfrm>
              </p:grpSpPr>
              <p:pic>
                <p:nvPicPr>
                  <p:cNvPr id="63" name="Picture 7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5416560" y="563760"/>
                    <a:ext cx="2203560" cy="18032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64" name="Rectangle 11"/>
                  <p:cNvSpPr/>
                  <p:nvPr/>
                </p:nvSpPr>
                <p:spPr>
                  <a:xfrm>
                    <a:off x="5873760" y="411120"/>
                    <a:ext cx="1219320" cy="304920"/>
                  </a:xfrm>
                  <a:prstGeom prst="rect">
                    <a:avLst/>
                  </a:pr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2400" spc="-1" strike="noStrike">
                        <a:solidFill>
                          <a:srgbClr val="000000"/>
                        </a:solidFill>
                        <a:latin typeface="ヒラギノ角ゴ ProN W3"/>
                      </a:rPr>
                      <a:t>_x0003_</a:t>
                    </a: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5" name="Rectangle 19"/>
                  <p:cNvSpPr/>
                  <p:nvPr/>
                </p:nvSpPr>
                <p:spPr>
                  <a:xfrm>
                    <a:off x="5340600" y="944640"/>
                    <a:ext cx="228600" cy="762120"/>
                  </a:xfrm>
                  <a:prstGeom prst="rect">
                    <a:avLst/>
                  </a:pr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66" name="Rectangle 15"/>
                <p:cNvSpPr/>
                <p:nvPr/>
              </p:nvSpPr>
              <p:spPr>
                <a:xfrm>
                  <a:off x="6102360" y="2197080"/>
                  <a:ext cx="1219320" cy="30492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400" spc="-1" strike="noStrike">
                      <a:solidFill>
                        <a:srgbClr val="000000"/>
                      </a:solidFill>
                      <a:latin typeface="ヒラギノ角ゴ ProN W3"/>
                    </a:rPr>
                    <a:t>_x0003_</a:t>
                  </a: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67" name="Rectangle 58"/>
              <p:cNvSpPr/>
              <p:nvPr/>
            </p:nvSpPr>
            <p:spPr>
              <a:xfrm>
                <a:off x="5950080" y="2239920"/>
                <a:ext cx="13449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GFP expressio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Text Box 61"/>
              <p:cNvSpPr/>
              <p:nvPr/>
            </p:nvSpPr>
            <p:spPr>
              <a:xfrm flipH="1" rot="16200000">
                <a:off x="4841280" y="1292040"/>
                <a:ext cx="1121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HA detectio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9" name="Text Box 69"/>
            <p:cNvSpPr/>
            <p:nvPr/>
          </p:nvSpPr>
          <p:spPr>
            <a:xfrm>
              <a:off x="1989360" y="533520"/>
              <a:ext cx="326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0" name="Group 71"/>
          <p:cNvGrpSpPr/>
          <p:nvPr/>
        </p:nvGrpSpPr>
        <p:grpSpPr>
          <a:xfrm>
            <a:off x="2129040" y="2679840"/>
            <a:ext cx="5643000" cy="2122560"/>
            <a:chOff x="2129040" y="2679840"/>
            <a:chExt cx="5643000" cy="2122560"/>
          </a:xfrm>
        </p:grpSpPr>
        <p:grpSp>
          <p:nvGrpSpPr>
            <p:cNvPr id="71" name="Group 66"/>
            <p:cNvGrpSpPr/>
            <p:nvPr/>
          </p:nvGrpSpPr>
          <p:grpSpPr>
            <a:xfrm>
              <a:off x="2842560" y="2679840"/>
              <a:ext cx="2402280" cy="2122560"/>
              <a:chOff x="2842560" y="2679840"/>
              <a:chExt cx="2402280" cy="2122560"/>
            </a:xfrm>
          </p:grpSpPr>
          <p:grpSp>
            <p:nvGrpSpPr>
              <p:cNvPr id="72" name="Group 26"/>
              <p:cNvGrpSpPr/>
              <p:nvPr/>
            </p:nvGrpSpPr>
            <p:grpSpPr>
              <a:xfrm>
                <a:off x="2965320" y="2679840"/>
                <a:ext cx="2279520" cy="2090160"/>
                <a:chOff x="2965320" y="2679840"/>
                <a:chExt cx="2279520" cy="2090160"/>
              </a:xfrm>
            </p:grpSpPr>
            <p:pic>
              <p:nvPicPr>
                <p:cNvPr id="73" name="Picture 6" descr=""/>
                <p:cNvPicPr/>
                <p:nvPr/>
              </p:nvPicPr>
              <p:blipFill>
                <a:blip r:embed="rId3"/>
                <a:stretch/>
              </p:blipFill>
              <p:spPr>
                <a:xfrm>
                  <a:off x="3041280" y="2832120"/>
                  <a:ext cx="2203560" cy="180288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74" name="Rectangle 12"/>
                <p:cNvSpPr/>
                <p:nvPr/>
              </p:nvSpPr>
              <p:spPr>
                <a:xfrm>
                  <a:off x="3574800" y="2679840"/>
                  <a:ext cx="1219320" cy="30456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400" spc="-1" strike="noStrike">
                      <a:solidFill>
                        <a:srgbClr val="000000"/>
                      </a:solidFill>
                      <a:latin typeface="ヒラギノ角ゴ ProN W3"/>
                    </a:rPr>
                    <a:t>_x0003_</a:t>
                  </a: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" name="Rectangle 16"/>
                <p:cNvSpPr/>
                <p:nvPr/>
              </p:nvSpPr>
              <p:spPr>
                <a:xfrm>
                  <a:off x="3651120" y="4465440"/>
                  <a:ext cx="1218960" cy="30456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400" spc="-1" strike="noStrike">
                      <a:solidFill>
                        <a:srgbClr val="000000"/>
                      </a:solidFill>
                      <a:latin typeface="ヒラギノ角ゴ ProN W3"/>
                    </a:rPr>
                    <a:t>_x0003_</a:t>
                  </a: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" name="Rectangle 20"/>
                <p:cNvSpPr/>
                <p:nvPr/>
              </p:nvSpPr>
              <p:spPr>
                <a:xfrm>
                  <a:off x="2965320" y="3213000"/>
                  <a:ext cx="228600" cy="76176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77" name="Text Box 55"/>
              <p:cNvSpPr/>
              <p:nvPr/>
            </p:nvSpPr>
            <p:spPr>
              <a:xfrm>
                <a:off x="3651120" y="4525920"/>
                <a:ext cx="13449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GFP expressio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Text Box 62"/>
              <p:cNvSpPr/>
              <p:nvPr/>
            </p:nvSpPr>
            <p:spPr>
              <a:xfrm flipH="1" rot="16200000">
                <a:off x="2400480" y="3502800"/>
                <a:ext cx="11606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HA detectio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9" name="Group 67"/>
            <p:cNvGrpSpPr/>
            <p:nvPr/>
          </p:nvGrpSpPr>
          <p:grpSpPr>
            <a:xfrm>
              <a:off x="5326920" y="2679840"/>
              <a:ext cx="2445120" cy="2105280"/>
              <a:chOff x="5326920" y="2679840"/>
              <a:chExt cx="2445120" cy="2105280"/>
            </a:xfrm>
          </p:grpSpPr>
          <p:grpSp>
            <p:nvGrpSpPr>
              <p:cNvPr id="80" name="Group 27"/>
              <p:cNvGrpSpPr/>
              <p:nvPr/>
            </p:nvGrpSpPr>
            <p:grpSpPr>
              <a:xfrm>
                <a:off x="5479920" y="2679840"/>
                <a:ext cx="2292120" cy="2079360"/>
                <a:chOff x="5479920" y="2679840"/>
                <a:chExt cx="2292120" cy="2079360"/>
              </a:xfrm>
            </p:grpSpPr>
            <p:pic>
              <p:nvPicPr>
                <p:cNvPr id="81" name="Picture 5" descr=""/>
                <p:cNvPicPr/>
                <p:nvPr/>
              </p:nvPicPr>
              <p:blipFill>
                <a:blip r:embed="rId4"/>
                <a:stretch/>
              </p:blipFill>
              <p:spPr>
                <a:xfrm>
                  <a:off x="5568840" y="2832120"/>
                  <a:ext cx="2203200" cy="180036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82" name="Rectangle 13"/>
                <p:cNvSpPr/>
                <p:nvPr/>
              </p:nvSpPr>
              <p:spPr>
                <a:xfrm>
                  <a:off x="6102000" y="2679840"/>
                  <a:ext cx="1219320" cy="30456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400" spc="-1" strike="noStrike">
                      <a:solidFill>
                        <a:srgbClr val="000000"/>
                      </a:solidFill>
                      <a:latin typeface="ヒラギノ角ゴ ProN W3"/>
                    </a:rPr>
                    <a:t>_x0003_</a:t>
                  </a: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" name="Rectangle 17"/>
                <p:cNvSpPr/>
                <p:nvPr/>
              </p:nvSpPr>
              <p:spPr>
                <a:xfrm>
                  <a:off x="6178320" y="4454640"/>
                  <a:ext cx="1219320" cy="30456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400" spc="-1" strike="noStrike">
                      <a:solidFill>
                        <a:srgbClr val="000000"/>
                      </a:solidFill>
                      <a:latin typeface="ヒラギノ角ゴ ProN W3"/>
                    </a:rPr>
                    <a:t>_x0003_</a:t>
                  </a: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" name="Rectangle 21"/>
                <p:cNvSpPr/>
                <p:nvPr/>
              </p:nvSpPr>
              <p:spPr>
                <a:xfrm>
                  <a:off x="5479920" y="3289320"/>
                  <a:ext cx="228600" cy="76212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85" name="Rectangle 59"/>
              <p:cNvSpPr/>
              <p:nvPr/>
            </p:nvSpPr>
            <p:spPr>
              <a:xfrm>
                <a:off x="6089760" y="4508640"/>
                <a:ext cx="13449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GFP expressio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Text Box 63"/>
              <p:cNvSpPr/>
              <p:nvPr/>
            </p:nvSpPr>
            <p:spPr>
              <a:xfrm flipH="1" rot="16200000">
                <a:off x="4904640" y="3560760"/>
                <a:ext cx="1121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HA detectio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7" name="Text Box 70"/>
            <p:cNvSpPr/>
            <p:nvPr/>
          </p:nvSpPr>
          <p:spPr>
            <a:xfrm>
              <a:off x="2129040" y="2876400"/>
              <a:ext cx="3834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B.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8" name=""/>
          <p:cNvSpPr/>
          <p:nvPr/>
        </p:nvSpPr>
        <p:spPr>
          <a:xfrm>
            <a:off x="609480" y="5029200"/>
            <a:ext cx="7925040" cy="162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ure S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The expression of PiT2K522E on productively GALV-GFP infected MDTF cells expressing PiT2K522E tagged with HA epitope. A. Uninfected MDTFPiT2K522E-HA cells. B.  MDTFPiT2K522E cells transduced with GALV-GFP viruses three weeks after initial viral exposure. The cells were unstained (left) or stained (right ) with anti-HA monoclonal antibodies and isotope specific secondary antibody conjugated with R-phyoerythrinan and analyzed by flow cytometry. The x-axis represents MFI of GFP expression and the y-axis represents MFI of HA expression on the cell surface. The experiment was performed three independent times, and images are from one representative experiment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6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3-26T22:23:59Z</dcterms:created>
  <dc:creator>NIMH NIH</dc:creator>
  <dc:description/>
  <dc:language>en-US</dc:language>
  <cp:lastModifiedBy>NIMH NIH</cp:lastModifiedBy>
  <dcterms:modified xsi:type="dcterms:W3CDTF">2012-04-05T18:25:12Z</dcterms:modified>
  <cp:revision>19</cp:revision>
  <dc:subject/>
  <dc:title>PowerPoint Presentation</dc:title>
</cp:coreProperties>
</file>